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0" r:id="rId3"/>
    <p:sldId id="261" r:id="rId4"/>
    <p:sldId id="262" r:id="rId5"/>
    <p:sldId id="263" r:id="rId6"/>
    <p:sldId id="258" r:id="rId7"/>
    <p:sldId id="264" r:id="rId8"/>
    <p:sldId id="265" r:id="rId9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53" autoAdjust="0"/>
    <p:restoredTop sz="94660"/>
  </p:normalViewPr>
  <p:slideViewPr>
    <p:cSldViewPr snapToGrid="0">
      <p:cViewPr>
        <p:scale>
          <a:sx n="80" d="100"/>
          <a:sy n="80" d="100"/>
        </p:scale>
        <p:origin x="2126" y="-21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718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786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849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880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485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378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719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771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666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602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479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02F629-C20B-4BEE-8962-5BB1DA3F5F9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59A41-A81F-4DAB-9722-BB0FB95199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200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466937A-7F65-D30E-BCA5-1BE0CEADCB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4747458"/>
              </p:ext>
            </p:extLst>
          </p:nvPr>
        </p:nvGraphicFramePr>
        <p:xfrm>
          <a:off x="121967" y="193142"/>
          <a:ext cx="6600098" cy="5835710"/>
        </p:xfrm>
        <a:graphic>
          <a:graphicData uri="http://schemas.openxmlformats.org/drawingml/2006/table">
            <a:tbl>
              <a:tblPr/>
              <a:tblGrid>
                <a:gridCol w="448056">
                  <a:extLst>
                    <a:ext uri="{9D8B030D-6E8A-4147-A177-3AD203B41FA5}">
                      <a16:colId xmlns:a16="http://schemas.microsoft.com/office/drawing/2014/main" val="235631611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1414554687"/>
                    </a:ext>
                  </a:extLst>
                </a:gridCol>
                <a:gridCol w="822960">
                  <a:extLst>
                    <a:ext uri="{9D8B030D-6E8A-4147-A177-3AD203B41FA5}">
                      <a16:colId xmlns:a16="http://schemas.microsoft.com/office/drawing/2014/main" val="2386094336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805193212"/>
                    </a:ext>
                  </a:extLst>
                </a:gridCol>
                <a:gridCol w="1280160">
                  <a:extLst>
                    <a:ext uri="{9D8B030D-6E8A-4147-A177-3AD203B41FA5}">
                      <a16:colId xmlns:a16="http://schemas.microsoft.com/office/drawing/2014/main" val="1543387251"/>
                    </a:ext>
                  </a:extLst>
                </a:gridCol>
                <a:gridCol w="612648">
                  <a:extLst>
                    <a:ext uri="{9D8B030D-6E8A-4147-A177-3AD203B41FA5}">
                      <a16:colId xmlns:a16="http://schemas.microsoft.com/office/drawing/2014/main" val="3462200267"/>
                    </a:ext>
                  </a:extLst>
                </a:gridCol>
                <a:gridCol w="651390">
                  <a:extLst>
                    <a:ext uri="{9D8B030D-6E8A-4147-A177-3AD203B41FA5}">
                      <a16:colId xmlns:a16="http://schemas.microsoft.com/office/drawing/2014/main" val="99620699"/>
                    </a:ext>
                  </a:extLst>
                </a:gridCol>
                <a:gridCol w="651390">
                  <a:extLst>
                    <a:ext uri="{9D8B030D-6E8A-4147-A177-3AD203B41FA5}">
                      <a16:colId xmlns:a16="http://schemas.microsoft.com/office/drawing/2014/main" val="1508984610"/>
                    </a:ext>
                  </a:extLst>
                </a:gridCol>
                <a:gridCol w="579014">
                  <a:extLst>
                    <a:ext uri="{9D8B030D-6E8A-4147-A177-3AD203B41FA5}">
                      <a16:colId xmlns:a16="http://schemas.microsoft.com/office/drawing/2014/main" val="597501452"/>
                    </a:ext>
                  </a:extLst>
                </a:gridCol>
              </a:tblGrid>
              <a:tr h="93454">
                <a:tc gridSpan="8">
                  <a:txBody>
                    <a:bodyPr/>
                    <a:lstStyle/>
                    <a:p>
                      <a:pPr algn="l" fontAlgn="b">
                        <a:tabLst/>
                      </a:pPr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1.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nges in soluble immune checkpoints upon treatment with immune checkpoint therapy </a:t>
                      </a: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8076364"/>
                  </a:ext>
                </a:extLst>
              </a:tr>
              <a:tr h="9667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223" marR="3223" marT="32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6043236"/>
                  </a:ext>
                </a:extLst>
              </a:tr>
              <a:tr h="2748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lyte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cer Type (n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terial 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od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of Change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epoint 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772368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D-L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20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PD-1 or a combination of αPD-1 + αCTLA4 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R&amp;D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-4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17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84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9267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rothelial (n=11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, </a:t>
                      </a:r>
                      <a:r>
                        <a:rPr lang="de-DE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B7H10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R&amp;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cycle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81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231676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per tract urothelial (n=4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</a:t>
                      </a:r>
                      <a:r>
                        <a:rPr lang="de-DE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B7H10 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R&amp;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month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89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724102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51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,</a:t>
                      </a:r>
                      <a:r>
                        <a:rPr lang="es-E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SEA788Hu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Cloud-Clone </a:t>
                      </a:r>
                      <a:r>
                        <a:rPr lang="es-E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rp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-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77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450410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142250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D-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 cancers (n=15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uoSet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Y1086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R&amp;D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cycles, </a:t>
                      </a:r>
                    </a:p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03, p=0.0010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07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867566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51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,</a:t>
                      </a:r>
                      <a:r>
                        <a:rPr lang="es-E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SEA751Hu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Cloud-Clone </a:t>
                      </a:r>
                      <a:r>
                        <a:rPr lang="es-E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rp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77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645415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2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683355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TLA4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407243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D80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140000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IM3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607877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AG3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 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7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208887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BTL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919202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 cancers (n=84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PD-1, combination of αPD-1 + αCTLA4, or other immune checkpoint inhibitors 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Panel 1, 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PX14A-15803-901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Fisher Scientific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-2, </a:t>
                      </a:r>
                    </a:p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-5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83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511668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VE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cycle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3223" marR="3223" marT="32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3780386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AFDF681-E507-981D-C062-461D000EE773}"/>
              </a:ext>
            </a:extLst>
          </p:cNvPr>
          <p:cNvSpPr txBox="1"/>
          <p:nvPr/>
        </p:nvSpPr>
        <p:spPr>
          <a:xfrm>
            <a:off x="121967" y="6028852"/>
            <a:ext cx="636905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Abbreviations: PFS </a:t>
            </a:r>
            <a:r>
              <a:rPr lang="en-US" sz="1000" dirty="0"/>
              <a:t>progression-free survival, </a:t>
            </a:r>
            <a:r>
              <a:rPr lang="en-US" sz="1000" i="1" dirty="0"/>
              <a:t>OS </a:t>
            </a:r>
            <a:r>
              <a:rPr lang="en-US" sz="1000" dirty="0"/>
              <a:t>overall survival, </a:t>
            </a:r>
            <a:r>
              <a:rPr lang="en-US" sz="1000" i="1" dirty="0" err="1"/>
              <a:t>hIO</a:t>
            </a:r>
            <a:r>
              <a:rPr lang="en-US" sz="1000" i="1" dirty="0"/>
              <a:t> </a:t>
            </a:r>
            <a:r>
              <a:rPr lang="en-US" sz="1000" dirty="0"/>
              <a:t>human Immuno-Oncology, </a:t>
            </a:r>
            <a:r>
              <a:rPr lang="en-US" sz="1000" i="1" dirty="0"/>
              <a:t>s</a:t>
            </a:r>
            <a:r>
              <a:rPr lang="en-US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D-L1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oluble programmed cell death-ligand 1, </a:t>
            </a:r>
            <a:r>
              <a:rPr lang="en-US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SCLC 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n-small cell lung cancer, </a:t>
            </a:r>
            <a:r>
              <a:rPr lang="en-US" sz="1000" i="1" dirty="0"/>
              <a:t>ns </a:t>
            </a:r>
            <a:r>
              <a:rPr lang="en-US" sz="1000" dirty="0"/>
              <a:t>not significant,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PD-1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programmed cell death protein 1, s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CTLA4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cytotoxic T-lymphocyte-associated antigen 4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CD80 </a:t>
            </a:r>
            <a:r>
              <a:rPr lang="en-US" sz="1000" dirty="0">
                <a:effectLst/>
                <a:ea typeface="Calibri" panose="020F0502020204030204" pitchFamily="34" charset="0"/>
              </a:rPr>
              <a:t>soluble CD80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TIM3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T cell immunoglobulin and mucin domain-containing protein 3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LAG3 </a:t>
            </a:r>
            <a:r>
              <a:rPr lang="en-US" sz="1000" dirty="0">
                <a:effectLst/>
                <a:ea typeface="Calibri" panose="020F0502020204030204" pitchFamily="34" charset="0"/>
              </a:rPr>
              <a:t>soluble lymphocyte activation gene 3,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sBTLA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B and T lymphocyte attenuator,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sHVEM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herpesvirus entry mediator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50326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35CAD72-0848-A5B6-5A0C-D8EBBCFA15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6294584"/>
              </p:ext>
            </p:extLst>
          </p:nvPr>
        </p:nvGraphicFramePr>
        <p:xfrm>
          <a:off x="85115" y="396131"/>
          <a:ext cx="6672029" cy="3797902"/>
        </p:xfrm>
        <a:graphic>
          <a:graphicData uri="http://schemas.openxmlformats.org/drawingml/2006/table">
            <a:tbl>
              <a:tblPr/>
              <a:tblGrid>
                <a:gridCol w="446882">
                  <a:extLst>
                    <a:ext uri="{9D8B030D-6E8A-4147-A177-3AD203B41FA5}">
                      <a16:colId xmlns:a16="http://schemas.microsoft.com/office/drawing/2014/main" val="3329294484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3470372685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583075415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842435661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1432853581"/>
                    </a:ext>
                  </a:extLst>
                </a:gridCol>
                <a:gridCol w="615075">
                  <a:extLst>
                    <a:ext uri="{9D8B030D-6E8A-4147-A177-3AD203B41FA5}">
                      <a16:colId xmlns:a16="http://schemas.microsoft.com/office/drawing/2014/main" val="1951537000"/>
                    </a:ext>
                  </a:extLst>
                </a:gridCol>
                <a:gridCol w="664218">
                  <a:extLst>
                    <a:ext uri="{9D8B030D-6E8A-4147-A177-3AD203B41FA5}">
                      <a16:colId xmlns:a16="http://schemas.microsoft.com/office/drawing/2014/main" val="155555071"/>
                    </a:ext>
                  </a:extLst>
                </a:gridCol>
                <a:gridCol w="664218">
                  <a:extLst>
                    <a:ext uri="{9D8B030D-6E8A-4147-A177-3AD203B41FA5}">
                      <a16:colId xmlns:a16="http://schemas.microsoft.com/office/drawing/2014/main" val="174084343"/>
                    </a:ext>
                  </a:extLst>
                </a:gridCol>
                <a:gridCol w="664218">
                  <a:extLst>
                    <a:ext uri="{9D8B030D-6E8A-4147-A177-3AD203B41FA5}">
                      <a16:colId xmlns:a16="http://schemas.microsoft.com/office/drawing/2014/main" val="2638381899"/>
                    </a:ext>
                  </a:extLst>
                </a:gridCol>
                <a:gridCol w="462738">
                  <a:extLst>
                    <a:ext uri="{9D8B030D-6E8A-4147-A177-3AD203B41FA5}">
                      <a16:colId xmlns:a16="http://schemas.microsoft.com/office/drawing/2014/main" val="1409243417"/>
                    </a:ext>
                  </a:extLst>
                </a:gridCol>
              </a:tblGrid>
              <a:tr h="0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ble S2.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aseline levels of other soluble immune checkpoints as indicators of clinical response to immune checkpoint therapy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7957719"/>
                  </a:ext>
                </a:extLst>
              </a:tr>
              <a:tr h="6879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6793404"/>
                  </a:ext>
                </a:extLst>
              </a:tr>
              <a:tr h="136754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nalyte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ssociation with Clinical Outcome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688743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l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ncer Type (n)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eatment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aterial 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ethod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utoff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esponse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FS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S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eference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945912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sPD-1</a:t>
                      </a:r>
                    </a:p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SCLC (n=5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D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,</a:t>
                      </a:r>
                      <a:r>
                        <a:rPr lang="es-E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SEA751Hu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Cloud-Clone </a:t>
                      </a:r>
                      <a:r>
                        <a:rPr lang="es-E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rp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156 ng/ml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 (p=0.007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7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284643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astric (n=43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D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utomated immuno-assay system (HISCL, Sysmex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60 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g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/ml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 (p=0.020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79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462328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lear cell renal cell (n=2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D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LISA (DYNABIO S.A.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.11 ng/ml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&lt;0.00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&lt;0.000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8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529294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sCTLA4</a:t>
                      </a:r>
                    </a:p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astric (n=43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D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utomated immuno-assay system (HISCL, Sysmex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2.3 pg/ml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 (p=0.008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79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375469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sTIM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ultiple cancers (n=11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D-1 or </a:t>
                      </a:r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D-L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4-ProcartaPlex 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Checkpoint Panel (Affymetrix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/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=0.0055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88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934945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sLAG3</a:t>
                      </a:r>
                    </a:p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dvanced head and neck  (n=23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hemotherapy or αPD-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Panel 1, 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PX14A-15803-901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Fisher Scientific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77 pg/ml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 (p=0.047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 (p=0.00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176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5841214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BTLA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ultiple cancers (n=84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αPD-1, combination of αPD-1 + αCTLA4, or other immune checkpoint inhibitors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Panel 1, 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PX14A-15803-901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Fisher Scientific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11.64 pg/ml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s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 (p=0.00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83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8246109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9D903CE9-0593-35A4-193C-E42BA0FC5775}"/>
              </a:ext>
            </a:extLst>
          </p:cNvPr>
          <p:cNvSpPr txBox="1"/>
          <p:nvPr/>
        </p:nvSpPr>
        <p:spPr>
          <a:xfrm>
            <a:off x="72413" y="4202397"/>
            <a:ext cx="636905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Abbreviations: PFS </a:t>
            </a:r>
            <a:r>
              <a:rPr lang="en-US" sz="1000" dirty="0"/>
              <a:t>progression-free survival, </a:t>
            </a:r>
            <a:r>
              <a:rPr lang="en-US" sz="1000" i="1" dirty="0"/>
              <a:t>OS </a:t>
            </a:r>
            <a:r>
              <a:rPr lang="en-US" sz="1000" dirty="0"/>
              <a:t>overall survival, </a:t>
            </a:r>
            <a:r>
              <a:rPr lang="en-US" sz="1000" i="1" dirty="0" err="1"/>
              <a:t>hIO</a:t>
            </a:r>
            <a:r>
              <a:rPr lang="en-US" sz="1000" i="1" dirty="0"/>
              <a:t> </a:t>
            </a:r>
            <a:r>
              <a:rPr lang="en-US" sz="1000" dirty="0"/>
              <a:t>human Immuno-Oncology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PD-1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programmed cell death protein 1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CTLA4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cytotoxic T-lymphocyte-associated antigen 4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TIM3 </a:t>
            </a:r>
            <a:r>
              <a:rPr lang="en-US" sz="1000" dirty="0">
                <a:effectLst/>
                <a:ea typeface="Calibri" panose="020F0502020204030204" pitchFamily="34" charset="0"/>
              </a:rPr>
              <a:t>soluble T cell immunoglobulin and mucin domain-containing protein 3, </a:t>
            </a:r>
            <a:r>
              <a:rPr lang="el-GR" sz="1000" i="1" dirty="0">
                <a:effectLst/>
                <a:ea typeface="Calibri" panose="020F0502020204030204" pitchFamily="34" charset="0"/>
              </a:rPr>
              <a:t>α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PD-L1</a:t>
            </a:r>
            <a:r>
              <a:rPr lang="en-US" sz="1000" dirty="0">
                <a:effectLst/>
                <a:ea typeface="Calibri" panose="020F0502020204030204" pitchFamily="34" charset="0"/>
              </a:rPr>
              <a:t>, anti-programmed cell death-ligand 1,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N/A</a:t>
            </a:r>
            <a:r>
              <a:rPr lang="en-US" sz="1000" dirty="0">
                <a:effectLst/>
                <a:ea typeface="Calibri" panose="020F0502020204030204" pitchFamily="34" charset="0"/>
              </a:rPr>
              <a:t> not applicable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LAG3 </a:t>
            </a:r>
            <a:r>
              <a:rPr lang="en-US" sz="1000" dirty="0">
                <a:effectLst/>
                <a:ea typeface="Calibri" panose="020F0502020204030204" pitchFamily="34" charset="0"/>
              </a:rPr>
              <a:t>soluble lymphocyte activation gene 3,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sBTLA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B and T lymphocyte attenuator</a:t>
            </a:r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1354467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267182B-0B72-44CF-16E7-58A95879F8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1518688"/>
              </p:ext>
            </p:extLst>
          </p:nvPr>
        </p:nvGraphicFramePr>
        <p:xfrm>
          <a:off x="113947" y="285568"/>
          <a:ext cx="6636878" cy="5675328"/>
        </p:xfrm>
        <a:graphic>
          <a:graphicData uri="http://schemas.openxmlformats.org/drawingml/2006/table">
            <a:tbl>
              <a:tblPr/>
              <a:tblGrid>
                <a:gridCol w="447083">
                  <a:extLst>
                    <a:ext uri="{9D8B030D-6E8A-4147-A177-3AD203B41FA5}">
                      <a16:colId xmlns:a16="http://schemas.microsoft.com/office/drawing/2014/main" val="3329294484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3470372685"/>
                    </a:ext>
                  </a:extLst>
                </a:gridCol>
                <a:gridCol w="640080">
                  <a:extLst>
                    <a:ext uri="{9D8B030D-6E8A-4147-A177-3AD203B41FA5}">
                      <a16:colId xmlns:a16="http://schemas.microsoft.com/office/drawing/2014/main" val="2583075415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842435661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1276792748"/>
                    </a:ext>
                  </a:extLst>
                </a:gridCol>
                <a:gridCol w="615352">
                  <a:extLst>
                    <a:ext uri="{9D8B030D-6E8A-4147-A177-3AD203B41FA5}">
                      <a16:colId xmlns:a16="http://schemas.microsoft.com/office/drawing/2014/main" val="1951537000"/>
                    </a:ext>
                  </a:extLst>
                </a:gridCol>
                <a:gridCol w="667512">
                  <a:extLst>
                    <a:ext uri="{9D8B030D-6E8A-4147-A177-3AD203B41FA5}">
                      <a16:colId xmlns:a16="http://schemas.microsoft.com/office/drawing/2014/main" val="155555071"/>
                    </a:ext>
                  </a:extLst>
                </a:gridCol>
                <a:gridCol w="667512">
                  <a:extLst>
                    <a:ext uri="{9D8B030D-6E8A-4147-A177-3AD203B41FA5}">
                      <a16:colId xmlns:a16="http://schemas.microsoft.com/office/drawing/2014/main" val="174084343"/>
                    </a:ext>
                  </a:extLst>
                </a:gridCol>
                <a:gridCol w="667512">
                  <a:extLst>
                    <a:ext uri="{9D8B030D-6E8A-4147-A177-3AD203B41FA5}">
                      <a16:colId xmlns:a16="http://schemas.microsoft.com/office/drawing/2014/main" val="2638381899"/>
                    </a:ext>
                  </a:extLst>
                </a:gridCol>
                <a:gridCol w="462947">
                  <a:extLst>
                    <a:ext uri="{9D8B030D-6E8A-4147-A177-3AD203B41FA5}">
                      <a16:colId xmlns:a16="http://schemas.microsoft.com/office/drawing/2014/main" val="1409243417"/>
                    </a:ext>
                  </a:extLst>
                </a:gridCol>
              </a:tblGrid>
              <a:tr h="35548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ble S3.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ost-treatment levels of other soluble immune checkpoints after immune checkpoint therapy</a:t>
                      </a:r>
                    </a:p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as indicators of clinical response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7957719"/>
                  </a:ext>
                </a:extLst>
              </a:tr>
              <a:tr h="3554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6793404"/>
                  </a:ext>
                </a:extLst>
              </a:tr>
              <a:tr h="7066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nalyte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ncer Type (n)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eatment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aterial 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ethod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irection </a:t>
                      </a:r>
                    </a:p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Post-treatment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ssociation with Clinical Outcome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6887432"/>
                  </a:ext>
                </a:extLst>
              </a:tr>
              <a:tr h="159980"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US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te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US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 Type (n)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US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reatment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US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aterial 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en-US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irection </a:t>
                      </a:r>
                    </a:p>
                    <a:p>
                      <a:pPr algn="ctr" fontAlgn="ctr"/>
                      <a:r>
                        <a:rPr lang="en-US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fter </a:t>
                      </a:r>
                    </a:p>
                    <a:p>
                      <a:pPr algn="ctr" fontAlgn="ctr"/>
                      <a:r>
                        <a:rPr lang="en-US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reatment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esponse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FS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OS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eference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945912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D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PD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3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233841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5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,</a:t>
                      </a:r>
                      <a:r>
                        <a:rPr lang="es-E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SEA751Hu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Cloud-Clone </a:t>
                      </a:r>
                      <a:r>
                        <a:rPr lang="es-E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rp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or =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4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2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7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937202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122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 or </a:t>
                      </a:r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yB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37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78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307576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ear cell renal cell (n=2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LISA (DYNABIO S.A.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78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1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8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596406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 cancers (n=15)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uoSet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Y1086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R&amp;D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24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0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975082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CTLA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↑ (p&lt;0.05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025281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TIM3</a:t>
                      </a:r>
                    </a:p>
                  </a:txBody>
                  <a:tcPr marL="6350" marR="6350" marT="635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D-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↑ (p&lt;0.00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↑ (p=0.005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404584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LAG3</a:t>
                      </a:r>
                    </a:p>
                  </a:txBody>
                  <a:tcPr marL="6350" marR="6350" marT="635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D-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↓ (p=0.02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093385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BTLA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D-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↑ (p&lt;0.0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↑ (p=0.02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902081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ultiple cancers (n=84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αPD-1, combination of αPD-1 + αCTLA4, or other immune checkpoint inhibitors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Panel 1, 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PX14A-15803-901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Fisher Scientific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↑ (p=0.00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83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98494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HVEM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SCLC (n=22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D-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↑ (p&lt;0.05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[90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669284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B8B21BD-1B86-8A71-812E-788928367DF8}"/>
              </a:ext>
            </a:extLst>
          </p:cNvPr>
          <p:cNvSpPr txBox="1"/>
          <p:nvPr/>
        </p:nvSpPr>
        <p:spPr>
          <a:xfrm>
            <a:off x="107175" y="5960896"/>
            <a:ext cx="636905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Abbreviations: PFS </a:t>
            </a:r>
            <a:r>
              <a:rPr lang="en-US" sz="1000" dirty="0"/>
              <a:t>progression-free survival, </a:t>
            </a:r>
            <a:r>
              <a:rPr lang="en-US" sz="1000" i="1" dirty="0"/>
              <a:t>OS </a:t>
            </a:r>
            <a:r>
              <a:rPr lang="en-US" sz="1000" dirty="0"/>
              <a:t>overall survival, </a:t>
            </a:r>
            <a:r>
              <a:rPr lang="en-US" sz="1000" i="1" dirty="0" err="1"/>
              <a:t>hIO</a:t>
            </a:r>
            <a:r>
              <a:rPr lang="en-US" sz="1000" i="1" dirty="0"/>
              <a:t> </a:t>
            </a:r>
            <a:r>
              <a:rPr lang="en-US" sz="1000" dirty="0"/>
              <a:t>human Immuno-Oncology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PD-1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programmed cell death protein 1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ns</a:t>
            </a:r>
            <a:r>
              <a:rPr lang="en-US" sz="1000" dirty="0">
                <a:effectLst/>
                <a:ea typeface="Calibri" panose="020F0502020204030204" pitchFamily="34" charset="0"/>
              </a:rPr>
              <a:t> not significant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CTLA4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cytotoxic T-lymphocyte-associated antigen 4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TIM3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T cell immunoglobulin and mucin domain-containing protein 3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LAG3 </a:t>
            </a:r>
            <a:r>
              <a:rPr lang="en-US" sz="1000" dirty="0">
                <a:effectLst/>
                <a:ea typeface="Calibri" panose="020F0502020204030204" pitchFamily="34" charset="0"/>
              </a:rPr>
              <a:t>soluble lymphocyte activation gene 3,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sBTLA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B and T lymphocyte attenuator,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sHVEM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herpesvirus entry mediator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9061046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E3CF876-6408-7F43-FC71-B23A82AD36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1317061"/>
              </p:ext>
            </p:extLst>
          </p:nvPr>
        </p:nvGraphicFramePr>
        <p:xfrm>
          <a:off x="47917" y="68885"/>
          <a:ext cx="6775704" cy="9523196"/>
        </p:xfrm>
        <a:graphic>
          <a:graphicData uri="http://schemas.openxmlformats.org/drawingml/2006/table">
            <a:tbl>
              <a:tblPr/>
              <a:tblGrid>
                <a:gridCol w="448056">
                  <a:extLst>
                    <a:ext uri="{9D8B030D-6E8A-4147-A177-3AD203B41FA5}">
                      <a16:colId xmlns:a16="http://schemas.microsoft.com/office/drawing/2014/main" val="2313936930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1294153392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58142169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212820761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2755660827"/>
                    </a:ext>
                  </a:extLst>
                </a:gridCol>
                <a:gridCol w="612648">
                  <a:extLst>
                    <a:ext uri="{9D8B030D-6E8A-4147-A177-3AD203B41FA5}">
                      <a16:colId xmlns:a16="http://schemas.microsoft.com/office/drawing/2014/main" val="1685093643"/>
                    </a:ext>
                  </a:extLst>
                </a:gridCol>
                <a:gridCol w="649224">
                  <a:extLst>
                    <a:ext uri="{9D8B030D-6E8A-4147-A177-3AD203B41FA5}">
                      <a16:colId xmlns:a16="http://schemas.microsoft.com/office/drawing/2014/main" val="228343696"/>
                    </a:ext>
                  </a:extLst>
                </a:gridCol>
                <a:gridCol w="649224">
                  <a:extLst>
                    <a:ext uri="{9D8B030D-6E8A-4147-A177-3AD203B41FA5}">
                      <a16:colId xmlns:a16="http://schemas.microsoft.com/office/drawing/2014/main" val="1650835844"/>
                    </a:ext>
                  </a:extLst>
                </a:gridCol>
                <a:gridCol w="576072">
                  <a:extLst>
                    <a:ext uri="{9D8B030D-6E8A-4147-A177-3AD203B41FA5}">
                      <a16:colId xmlns:a16="http://schemas.microsoft.com/office/drawing/2014/main" val="2373448078"/>
                    </a:ext>
                  </a:extLst>
                </a:gridCol>
              </a:tblGrid>
              <a:tr h="40482">
                <a:tc gridSpan="7"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4.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nges in sPD-L1 upon treatment with conventional therapies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6373067"/>
                  </a:ext>
                </a:extLst>
              </a:tr>
              <a:tr h="41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2075114"/>
                  </a:ext>
                </a:extLst>
              </a:tr>
              <a:tr h="1190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lyt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cer Type (n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terial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od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</a:t>
                      </a:r>
                    </a:p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 Chang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epoint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119118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D-L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18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em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CUSABIO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month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2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2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997476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6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Abcam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, 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month, 3 month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1, p=0.019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782726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 (n=53)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orafeni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weeks, 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05, p=0.003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730005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 (n=12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Merck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2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254631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34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iotherapy (conventional fractionated radiotherapy with hepatic arterial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fusional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motherapy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R&amp;D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, 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, 1 month follow-up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71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571216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19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iotherapy (stereotactic body radiotherapy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R&amp;D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, 1 month follow-up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951675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70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203755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rectal (n=117)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A788Hu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Cloud-Clone Corp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9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493749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nal cell (n=1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</a:t>
                      </a:r>
                      <a:r>
                        <a:rPr lang="pt-BR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B7H10</a:t>
                      </a: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R&amp;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1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409034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per tract urothelial (n=14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</a:t>
                      </a:r>
                      <a:r>
                        <a:rPr lang="de-DE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B7H10 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R&amp;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y 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1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89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508220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cervical  (n=5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urrent chemoradiotherapy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®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 after end of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6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0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62676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rly breast  (n=7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therapy  and 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® MAP Kit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1-11K-PX17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erck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887528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sopharyngeal (n=3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initive intensity-modulated 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1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Bioscienc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800" b="0" i="1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5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791283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ophageal adenocarcinoma (n=1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, with or without neoadjuvant and/or adjuvant chemotherapy or chemo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custom kits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s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Scale Diagnostics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y 3, day 7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1, p&lt;0.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2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856004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gefitinib, n=2; erlotinib, n=1; dacomitinib, n=2) or nivolumab (n=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CUSABIO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month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2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620243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stric (n=30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Shanghai Sinovac Biotechnology Co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day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8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027688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4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nvatini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33152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50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</a:t>
                      </a:r>
                      <a:r>
                        <a:rPr lang="fi-FI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-B12533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day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51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502969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astatic clear cell renal cell (n=50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unitini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 (DYNABIO S.A.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22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820705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astatic clear cell renal cell (n=3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bevacizuma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 (DYNABIO S.A.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997991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rothelial (n=58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emotherapy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, </a:t>
                      </a:r>
                      <a:r>
                        <a:rPr lang="de-DE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B7H10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R&amp;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-2 cycle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81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076817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per tract urothelial (n=18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emotherapy (post-operative platinum therapy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</a:t>
                      </a:r>
                      <a:r>
                        <a:rPr lang="de-DE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B7H10 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R&amp;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cycl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89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190088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ple-negative breast (n=66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iangla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iological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4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15660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126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DCD1LG1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USCN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weeks, 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1, p&lt;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2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589816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orectal  with liver metastasis (n=49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R&amp;D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2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486577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rectal (n=30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LIPLEX® MAP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Millipore Sigma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4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10213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sopharyngeal (n=30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iotherapy or chemo-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b214565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Abcam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55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311244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87625F0-E68C-47A0-954F-AC682F36E5A9}"/>
              </a:ext>
            </a:extLst>
          </p:cNvPr>
          <p:cNvSpPr txBox="1"/>
          <p:nvPr/>
        </p:nvSpPr>
        <p:spPr>
          <a:xfrm>
            <a:off x="149523" y="9580824"/>
            <a:ext cx="6369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bbreviations: s</a:t>
            </a:r>
            <a:r>
              <a:rPr lang="en-US" sz="9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D-L1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oluble programmed cell death-ligand 1, </a:t>
            </a:r>
            <a:r>
              <a:rPr lang="en-US" sz="9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O</a:t>
            </a:r>
            <a:r>
              <a:rPr lang="en-US" sz="9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uman Immuno-Oncology, </a:t>
            </a:r>
            <a:r>
              <a:rPr lang="en-US" sz="9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x</a:t>
            </a:r>
            <a:r>
              <a:rPr lang="en-US" sz="9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eatment, </a:t>
            </a:r>
            <a:r>
              <a:rPr lang="en-US" sz="9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CSLC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on-small cell lung cancer, </a:t>
            </a:r>
            <a:r>
              <a:rPr lang="en-US" sz="9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s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t significant, </a:t>
            </a:r>
            <a:r>
              <a:rPr lang="en-US" sz="9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CE </a:t>
            </a:r>
            <a:r>
              <a:rPr lang="en-US" sz="900" b="0" i="0" dirty="0" err="1">
                <a:solidFill>
                  <a:srgbClr val="202124"/>
                </a:solidFill>
                <a:effectLst/>
                <a:latin typeface="Google Sans"/>
              </a:rPr>
              <a:t>transarterial</a:t>
            </a:r>
            <a:r>
              <a:rPr lang="en-US" sz="900" b="0" i="0" dirty="0">
                <a:solidFill>
                  <a:srgbClr val="202124"/>
                </a:solidFill>
                <a:effectLst/>
                <a:latin typeface="Google Sans"/>
              </a:rPr>
              <a:t> chemoembolization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018742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E3CF876-6408-7F43-FC71-B23A82AD36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8854401"/>
              </p:ext>
            </p:extLst>
          </p:nvPr>
        </p:nvGraphicFramePr>
        <p:xfrm>
          <a:off x="115653" y="212820"/>
          <a:ext cx="6592824" cy="9081236"/>
        </p:xfrm>
        <a:graphic>
          <a:graphicData uri="http://schemas.openxmlformats.org/drawingml/2006/table">
            <a:tbl>
              <a:tblPr/>
              <a:tblGrid>
                <a:gridCol w="448056">
                  <a:extLst>
                    <a:ext uri="{9D8B030D-6E8A-4147-A177-3AD203B41FA5}">
                      <a16:colId xmlns:a16="http://schemas.microsoft.com/office/drawing/2014/main" val="2313936930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1294153392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58142169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212820761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3689546274"/>
                    </a:ext>
                  </a:extLst>
                </a:gridCol>
                <a:gridCol w="612648">
                  <a:extLst>
                    <a:ext uri="{9D8B030D-6E8A-4147-A177-3AD203B41FA5}">
                      <a16:colId xmlns:a16="http://schemas.microsoft.com/office/drawing/2014/main" val="1685093643"/>
                    </a:ext>
                  </a:extLst>
                </a:gridCol>
                <a:gridCol w="649224">
                  <a:extLst>
                    <a:ext uri="{9D8B030D-6E8A-4147-A177-3AD203B41FA5}">
                      <a16:colId xmlns:a16="http://schemas.microsoft.com/office/drawing/2014/main" val="228343696"/>
                    </a:ext>
                  </a:extLst>
                </a:gridCol>
                <a:gridCol w="649224">
                  <a:extLst>
                    <a:ext uri="{9D8B030D-6E8A-4147-A177-3AD203B41FA5}">
                      <a16:colId xmlns:a16="http://schemas.microsoft.com/office/drawing/2014/main" val="1650835844"/>
                    </a:ext>
                  </a:extLst>
                </a:gridCol>
                <a:gridCol w="576072">
                  <a:extLst>
                    <a:ext uri="{9D8B030D-6E8A-4147-A177-3AD203B41FA5}">
                      <a16:colId xmlns:a16="http://schemas.microsoft.com/office/drawing/2014/main" val="2373448078"/>
                    </a:ext>
                  </a:extLst>
                </a:gridCol>
              </a:tblGrid>
              <a:tr h="40482"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5.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nges in sPD-1 and sCTLA4 upon treatment with conventional therapies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6373067"/>
                  </a:ext>
                </a:extLst>
              </a:tr>
              <a:tr h="41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2075114"/>
                  </a:ext>
                </a:extLst>
              </a:tr>
              <a:tr h="1190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lyt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cer Type (n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terial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od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</a:t>
                      </a:r>
                    </a:p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 Chang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epoint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119118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D-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(n=38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erlotini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uoSet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Y1086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R&amp;D)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e of progression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15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6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647145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stric (n=30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Shanghai Sinovac Biotechnology Co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day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8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055069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53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orafeni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, 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weeks, 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07, p=0.012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304697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cervical (n=5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urrent chemoradiotherapy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®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 after end of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1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0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148321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sopharyngeal (n=3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initive intensity-modulated 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1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Bioscienc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≤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5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025273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 (n=2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063363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4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nvatini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653250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astatic clear cell renal cell (n=50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unitini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 (DYNABIO S.A.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22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579553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astatic clear cell renal cell (n=3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bevacizuma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LISA (DYNABIO S.A.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985007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nal cell (n=1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uoSet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Y1086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R&amp;D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1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507621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rectal (n=113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A751Hu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Cloud-Clone Corp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9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991727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ple-negative breast  (n=66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iangla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iological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4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237378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rly breast (n=7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therapy  and 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® MAP Kit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1-11K-PX17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erck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151109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astatic renal cell (n=20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unitinib or pazopanib) as first-line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PX14A-15803-901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Bioscienc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-4 month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2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5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923304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ophageal adenocarcinoma (n=1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, with or without neoadjuvant and/or adjuvant chemotherapy or chemo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custom kits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s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Scale Diagnostics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, ↓, 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day, 3 days, 42 day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n-NO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1, p&lt;0.001, p&lt;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2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04310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TLA4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 (n=53)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orafeni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, 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weeks, 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07, p=0.012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478484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5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926444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nic hepatitis C-hepatocellular  (n=35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iofrequency ablation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days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40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26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144437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cervical (n=5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urrent chemoradiotherapy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®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 after end of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1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0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899453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ophageal adenocarcinoma (n=1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, with or without neoadjuvant and/or adjuvant chemotherapy or chemo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custom kits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s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Scale Diagnostics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3 days, 7 day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5, p&lt;0.05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2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656910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 cancers (n=14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rst-line radiotherapy, chemotherapy or chemoradiotherapy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uche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iotech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da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28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49997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4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nvatini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493998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sopharyngeal (n=3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initive intensity-modulated 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1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Bioscienc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5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620905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rly breast (n=7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therapy and 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® MAP Kit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1-11K-PX17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erck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431241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9806FF5-6CC5-D13D-C162-4379C725D7BD}"/>
              </a:ext>
            </a:extLst>
          </p:cNvPr>
          <p:cNvSpPr txBox="1"/>
          <p:nvPr/>
        </p:nvSpPr>
        <p:spPr>
          <a:xfrm>
            <a:off x="115653" y="9293070"/>
            <a:ext cx="6267450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i="1" dirty="0"/>
              <a:t>Abbreviations:</a:t>
            </a:r>
            <a:r>
              <a:rPr lang="en-US" sz="1000" dirty="0"/>
              <a:t>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PD-1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programmed cell death protein 1,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hIO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 </a:t>
            </a:r>
            <a:r>
              <a:rPr lang="en-US" sz="1000" dirty="0">
                <a:effectLst/>
                <a:ea typeface="Calibri" panose="020F0502020204030204" pitchFamily="34" charset="0"/>
              </a:rPr>
              <a:t>human Immuno-Oncology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NSCLC</a:t>
            </a:r>
            <a:r>
              <a:rPr lang="en-US" sz="1000" dirty="0">
                <a:effectLst/>
                <a:ea typeface="Calibri" panose="020F0502020204030204" pitchFamily="34" charset="0"/>
              </a:rPr>
              <a:t> non-small cell lung cancer,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tx</a:t>
            </a:r>
            <a:r>
              <a:rPr lang="en-US" sz="1000" dirty="0">
                <a:effectLst/>
                <a:ea typeface="Calibri" panose="020F0502020204030204" pitchFamily="34" charset="0"/>
              </a:rPr>
              <a:t> treatment, </a:t>
            </a:r>
            <a:r>
              <a:rPr lang="en-US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CE </a:t>
            </a:r>
            <a:r>
              <a:rPr lang="en-US" sz="1000" b="0" i="0" dirty="0" err="1">
                <a:solidFill>
                  <a:srgbClr val="202124"/>
                </a:solidFill>
                <a:effectLst/>
                <a:latin typeface="Google Sans"/>
              </a:rPr>
              <a:t>transarterial</a:t>
            </a:r>
            <a:r>
              <a:rPr lang="en-US" sz="1000" b="0" i="0" dirty="0">
                <a:solidFill>
                  <a:srgbClr val="202124"/>
                </a:solidFill>
                <a:effectLst/>
                <a:latin typeface="Google Sans"/>
              </a:rPr>
              <a:t> chemoembolization</a:t>
            </a:r>
            <a:r>
              <a:rPr lang="en-US" sz="1000" b="0" i="0" dirty="0">
                <a:solidFill>
                  <a:srgbClr val="202124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b="0" i="1" dirty="0">
                <a:solidFill>
                  <a:srgbClr val="202124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ns</a:t>
            </a:r>
            <a:r>
              <a:rPr lang="en-US" sz="1000" b="0" dirty="0">
                <a:solidFill>
                  <a:srgbClr val="202124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 not significant,</a:t>
            </a:r>
            <a:r>
              <a:rPr lang="en-US" sz="1000" b="0" i="0" dirty="0">
                <a:solidFill>
                  <a:srgbClr val="202124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 s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CTLA4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cytotoxic T-lymphocyte-associated antigen 4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0538369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385FEDB-7C55-4BAE-B899-F12DD050B2F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2939994"/>
              </p:ext>
            </p:extLst>
          </p:nvPr>
        </p:nvGraphicFramePr>
        <p:xfrm>
          <a:off x="50603" y="62049"/>
          <a:ext cx="6765995" cy="7907988"/>
        </p:xfrm>
        <a:graphic>
          <a:graphicData uri="http://schemas.openxmlformats.org/drawingml/2006/table">
            <a:tbl>
              <a:tblPr/>
              <a:tblGrid>
                <a:gridCol w="446762">
                  <a:extLst>
                    <a:ext uri="{9D8B030D-6E8A-4147-A177-3AD203B41FA5}">
                      <a16:colId xmlns:a16="http://schemas.microsoft.com/office/drawing/2014/main" val="3329294484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3470372685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583075415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84243566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70451223"/>
                    </a:ext>
                  </a:extLst>
                </a:gridCol>
                <a:gridCol w="614909">
                  <a:extLst>
                    <a:ext uri="{9D8B030D-6E8A-4147-A177-3AD203B41FA5}">
                      <a16:colId xmlns:a16="http://schemas.microsoft.com/office/drawing/2014/main" val="1951537000"/>
                    </a:ext>
                  </a:extLst>
                </a:gridCol>
                <a:gridCol w="664039">
                  <a:extLst>
                    <a:ext uri="{9D8B030D-6E8A-4147-A177-3AD203B41FA5}">
                      <a16:colId xmlns:a16="http://schemas.microsoft.com/office/drawing/2014/main" val="155555071"/>
                    </a:ext>
                  </a:extLst>
                </a:gridCol>
                <a:gridCol w="664039">
                  <a:extLst>
                    <a:ext uri="{9D8B030D-6E8A-4147-A177-3AD203B41FA5}">
                      <a16:colId xmlns:a16="http://schemas.microsoft.com/office/drawing/2014/main" val="174084343"/>
                    </a:ext>
                  </a:extLst>
                </a:gridCol>
                <a:gridCol w="667512">
                  <a:extLst>
                    <a:ext uri="{9D8B030D-6E8A-4147-A177-3AD203B41FA5}">
                      <a16:colId xmlns:a16="http://schemas.microsoft.com/office/drawing/2014/main" val="2638381899"/>
                    </a:ext>
                  </a:extLst>
                </a:gridCol>
                <a:gridCol w="462614">
                  <a:extLst>
                    <a:ext uri="{9D8B030D-6E8A-4147-A177-3AD203B41FA5}">
                      <a16:colId xmlns:a16="http://schemas.microsoft.com/office/drawing/2014/main" val="1409243417"/>
                    </a:ext>
                  </a:extLst>
                </a:gridCol>
              </a:tblGrid>
              <a:tr h="35548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able S6.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ost-treatment levels of other soluble immune checkpoints after conventional therapies</a:t>
                      </a:r>
                    </a:p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 indicators of clinical response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7957719"/>
                  </a:ext>
                </a:extLst>
              </a:tr>
              <a:tr h="3554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6793404"/>
                  </a:ext>
                </a:extLst>
              </a:tr>
              <a:tr h="7066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te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 Type (n)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reatment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aterial 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ethod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irection  Post-treatment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sociation with Clinical Outcom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6887432"/>
                  </a:ext>
                </a:extLst>
              </a:tr>
              <a:tr h="159980"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te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 Type (n)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reatment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aterial 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irection After Treatment</a:t>
                      </a:r>
                    </a:p>
                  </a:txBody>
                  <a:tcPr marL="1606" marR="1606" marT="160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Response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FS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S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Reference</a:t>
                      </a:r>
                    </a:p>
                  </a:txBody>
                  <a:tcPr marL="1606" marR="1606" marT="160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945912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PD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riple-negative breast (n=66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eoadjuvant chemotherapy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LISA (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Jianglai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Biological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=0.01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64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96490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SCLC (n=38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argeted therapy (erlotinib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uoSet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Y1086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R&amp;D)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=0.013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=0.006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46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631703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epatocellular  (n=53)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argeted therapy (sorafenib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s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3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397359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astric (n=30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urgery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Shanghai Sinovac Biotechnology Co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=0.036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68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811900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CTLA4</a:t>
                      </a:r>
                    </a:p>
                  </a:txBody>
                  <a:tcPr marL="6350" marR="6350" marT="635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etastatic renal cell (n=20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argeted therapy (sunitinib or pazopanib) as first-line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PX14A-15803-901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Bioscienc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=0.006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45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093385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epatocellular  (n=53)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argeted therapy (sorafenib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s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3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979205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hronic hepatitis C-hepatocellular  (n=35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adiofrequency ablat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LIS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=0.038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126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339753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ultiple cancers (n=14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irst-line radiotherapy, chemotherapy or chemoradiotherapy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uche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iotech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&lt;0.05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&lt;0.05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4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902081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CD8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epatocellular  (n=53)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argeted therapy (sorafenib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s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3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669284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ocally advanced rectal  (n=30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eoadjuvant chemoradiotherapy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LIPLEX® MAP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Millipore Sigma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&lt;0.05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44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018819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TIM3</a:t>
                      </a:r>
                    </a:p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epatocellular  (n=53)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argeted therapy (sorafenib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s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3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026129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epatocellular (n=33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AC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LISA, 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MS2219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Fisher Scientific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=0.028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152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236235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LAG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epatocellular  (n=53)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argeted therapy (sorafenib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s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3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583902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ocally advanced cervical (n=5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oncurrent chemoradiotherapy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®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illipore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=0.00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40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000469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epatocellular (n=22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AC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ru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S2211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↓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(p=0.020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51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706142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BTLA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epatocellular  (n=53)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argeted therapy (sorafenib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s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3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868443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HVEM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epatocellular  (n=53)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argeted therapy (sorafenib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lasm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s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[237]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795420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EA5B74F-E789-5EC6-1FB9-5B5132A081B3}"/>
              </a:ext>
            </a:extLst>
          </p:cNvPr>
          <p:cNvSpPr txBox="1"/>
          <p:nvPr/>
        </p:nvSpPr>
        <p:spPr>
          <a:xfrm>
            <a:off x="50603" y="7977235"/>
            <a:ext cx="6502722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i="1" dirty="0"/>
              <a:t>Abbreviations: PFS </a:t>
            </a:r>
            <a:r>
              <a:rPr lang="en-US" sz="1000" dirty="0"/>
              <a:t>progression-free survival, </a:t>
            </a:r>
            <a:r>
              <a:rPr lang="en-US" sz="1000" i="1" dirty="0"/>
              <a:t>OS </a:t>
            </a:r>
            <a:r>
              <a:rPr lang="en-US" sz="1000" dirty="0"/>
              <a:t>overall survival, </a:t>
            </a:r>
            <a:r>
              <a:rPr lang="en-US" sz="1000" i="1" dirty="0" err="1"/>
              <a:t>hIO</a:t>
            </a:r>
            <a:r>
              <a:rPr lang="en-US" sz="1000" i="1" dirty="0"/>
              <a:t> </a:t>
            </a:r>
            <a:r>
              <a:rPr lang="en-US" sz="1000" dirty="0"/>
              <a:t>human Immuno-Oncology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PD-1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programmed cell death protein 1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ns</a:t>
            </a:r>
            <a:r>
              <a:rPr lang="en-US" sz="1000" dirty="0">
                <a:effectLst/>
                <a:ea typeface="Calibri" panose="020F0502020204030204" pitchFamily="34" charset="0"/>
              </a:rPr>
              <a:t> not significant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CTLA4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cytotoxic T-lymphocyte-associated antigen 4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CD80 </a:t>
            </a:r>
            <a:r>
              <a:rPr lang="en-US" sz="1000" i="1" dirty="0">
                <a:ea typeface="Calibri" panose="020F0502020204030204" pitchFamily="34" charset="0"/>
              </a:rPr>
              <a:t>soluble CD80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TIM3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T cell immunoglobulin and mucin domain-containing protein 3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TACE</a:t>
            </a:r>
            <a:r>
              <a:rPr lang="en-US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b="0" i="0" dirty="0" err="1">
                <a:solidFill>
                  <a:srgbClr val="202124"/>
                </a:solidFill>
                <a:effectLst/>
                <a:latin typeface="Google Sans"/>
              </a:rPr>
              <a:t>transarterial</a:t>
            </a:r>
            <a:r>
              <a:rPr lang="en-US" sz="1000" b="0" i="0" dirty="0">
                <a:solidFill>
                  <a:srgbClr val="202124"/>
                </a:solidFill>
                <a:effectLst/>
                <a:latin typeface="Google Sans"/>
              </a:rPr>
              <a:t> chemoembolization,</a:t>
            </a:r>
            <a:r>
              <a:rPr lang="en-US" sz="1000" dirty="0">
                <a:effectLst/>
                <a:ea typeface="Calibri" panose="020F0502020204030204" pitchFamily="34" charset="0"/>
              </a:rPr>
              <a:t>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sLAG3 </a:t>
            </a:r>
            <a:r>
              <a:rPr lang="en-US" sz="1000" dirty="0">
                <a:effectLst/>
                <a:ea typeface="Calibri" panose="020F0502020204030204" pitchFamily="34" charset="0"/>
              </a:rPr>
              <a:t>soluble lymphocyte activation gene 3,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sBTLA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B and T lymphocyte attenuator,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sHVEM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herpesvirus entry mediator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4555499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E3CF876-6408-7F43-FC71-B23A82AD36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7383679"/>
              </p:ext>
            </p:extLst>
          </p:nvPr>
        </p:nvGraphicFramePr>
        <p:xfrm>
          <a:off x="64851" y="22320"/>
          <a:ext cx="6729984" cy="9585552"/>
        </p:xfrm>
        <a:graphic>
          <a:graphicData uri="http://schemas.openxmlformats.org/drawingml/2006/table">
            <a:tbl>
              <a:tblPr/>
              <a:tblGrid>
                <a:gridCol w="448056">
                  <a:extLst>
                    <a:ext uri="{9D8B030D-6E8A-4147-A177-3AD203B41FA5}">
                      <a16:colId xmlns:a16="http://schemas.microsoft.com/office/drawing/2014/main" val="2313936930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1294153392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58142169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212820761"/>
                    </a:ext>
                  </a:extLst>
                </a:gridCol>
                <a:gridCol w="1325880">
                  <a:extLst>
                    <a:ext uri="{9D8B030D-6E8A-4147-A177-3AD203B41FA5}">
                      <a16:colId xmlns:a16="http://schemas.microsoft.com/office/drawing/2014/main" val="1383720613"/>
                    </a:ext>
                  </a:extLst>
                </a:gridCol>
                <a:gridCol w="612648">
                  <a:extLst>
                    <a:ext uri="{9D8B030D-6E8A-4147-A177-3AD203B41FA5}">
                      <a16:colId xmlns:a16="http://schemas.microsoft.com/office/drawing/2014/main" val="1685093643"/>
                    </a:ext>
                  </a:extLst>
                </a:gridCol>
                <a:gridCol w="649224">
                  <a:extLst>
                    <a:ext uri="{9D8B030D-6E8A-4147-A177-3AD203B41FA5}">
                      <a16:colId xmlns:a16="http://schemas.microsoft.com/office/drawing/2014/main" val="228343696"/>
                    </a:ext>
                  </a:extLst>
                </a:gridCol>
                <a:gridCol w="649224">
                  <a:extLst>
                    <a:ext uri="{9D8B030D-6E8A-4147-A177-3AD203B41FA5}">
                      <a16:colId xmlns:a16="http://schemas.microsoft.com/office/drawing/2014/main" val="1650835844"/>
                    </a:ext>
                  </a:extLst>
                </a:gridCol>
                <a:gridCol w="576072">
                  <a:extLst>
                    <a:ext uri="{9D8B030D-6E8A-4147-A177-3AD203B41FA5}">
                      <a16:colId xmlns:a16="http://schemas.microsoft.com/office/drawing/2014/main" val="2373448078"/>
                    </a:ext>
                  </a:extLst>
                </a:gridCol>
              </a:tblGrid>
              <a:tr h="40482"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7.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nges in sCD80, sTIM3, and sLAG3 upon treatment with conventional therapies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6373067"/>
                  </a:ext>
                </a:extLst>
              </a:tr>
              <a:tr h="41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2075114"/>
                  </a:ext>
                </a:extLst>
              </a:tr>
              <a:tr h="1190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lyt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cer Type (n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terial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od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</a:t>
                      </a:r>
                    </a:p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 Chang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epoint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119118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D80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carcinoma (n=2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36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310423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cervical (n=5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urrent chemoradiotherapy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®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 after end of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9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0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0973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rly breast (n=7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therapy and 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® MAP Kit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1-11K-PX17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erck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972337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4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nvatini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925507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sopharyngeal (n=3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initive intensity-modulated 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1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Bioscienc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5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589099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53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orafeni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, 2 weeks, 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n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45, p=0.0007, p=0.016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057314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rectal (n=30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LIPLEX® MAP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Millipore Sigma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4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170408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IM3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9906295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4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nvatini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9809924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33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LISA, 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MS2219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Fisher Scientific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36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152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229145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cervical (n=5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urrent chemoradiotherapy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®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-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4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0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292491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rly breast (n=7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therapy and 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® MAP Kit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1-11K-PX17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erck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363191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sopharyngeal (n=3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initive intensity-modulated 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1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Bioscienc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800" b="0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5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4761075"/>
                  </a:ext>
                </a:extLst>
              </a:tr>
              <a:tr h="385365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ophageal adenocarcinoma (n=1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, with or without neoadjuvant and/or adjuvant chemotherapy or chemo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custom kits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s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Scale Diagnostics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day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5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2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157521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53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orafeni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16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008616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fferentiated thyroid (n=30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231932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Abcam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-9 month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56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310013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AG3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53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orafeni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weeks, 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2, p=0.016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89995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rly breast (n=7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therapy  and 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® MAP Kit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1-11K-PX17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erck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671563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661809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4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nvatini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96343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cervical (n=5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urrent chemoradiotherapy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®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0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847158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S2211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isher Scientific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day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51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382387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sopharyngeal (n=3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initive intensity-modulated 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1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Bioscienc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≤0.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5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13345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ophageal adenocarcinoma (n=1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gery, with or without neoadjuvant and/or adjuvant chemotherapy or chemo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SA, custom kits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s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Scale Diagnostics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day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5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2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491694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C5A938B-EE65-3CD6-60FF-E54819C819B9}"/>
              </a:ext>
            </a:extLst>
          </p:cNvPr>
          <p:cNvSpPr txBox="1"/>
          <p:nvPr/>
        </p:nvSpPr>
        <p:spPr>
          <a:xfrm>
            <a:off x="102953" y="9594725"/>
            <a:ext cx="60325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i="1" dirty="0"/>
              <a:t>Abbreviations: </a:t>
            </a:r>
            <a:r>
              <a:rPr lang="en-US" sz="800" i="1" dirty="0">
                <a:effectLst/>
                <a:ea typeface="Calibri" panose="020F0502020204030204" pitchFamily="34" charset="0"/>
              </a:rPr>
              <a:t>sCD80 </a:t>
            </a:r>
            <a:r>
              <a:rPr lang="en-US" sz="800" i="1" dirty="0">
                <a:ea typeface="Calibri" panose="020F0502020204030204" pitchFamily="34" charset="0"/>
              </a:rPr>
              <a:t>soluble CD80, </a:t>
            </a:r>
            <a:r>
              <a:rPr lang="en-US" sz="800" i="1" dirty="0">
                <a:effectLst/>
                <a:ea typeface="Calibri" panose="020F0502020204030204" pitchFamily="34" charset="0"/>
              </a:rPr>
              <a:t>TACE</a:t>
            </a:r>
            <a:r>
              <a:rPr lang="en-US" sz="8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800" b="0" i="0" dirty="0" err="1">
                <a:solidFill>
                  <a:srgbClr val="202124"/>
                </a:solidFill>
                <a:effectLst/>
                <a:latin typeface="Google Sans"/>
              </a:rPr>
              <a:t>transarterial</a:t>
            </a:r>
            <a:r>
              <a:rPr lang="en-US" sz="800" b="0" i="0" dirty="0">
                <a:solidFill>
                  <a:srgbClr val="202124"/>
                </a:solidFill>
                <a:effectLst/>
                <a:latin typeface="Google Sans"/>
              </a:rPr>
              <a:t> chemoembolization, </a:t>
            </a:r>
            <a:r>
              <a:rPr lang="en-US" sz="800" b="0" i="1" dirty="0" err="1">
                <a:solidFill>
                  <a:srgbClr val="202124"/>
                </a:solidFill>
                <a:effectLst/>
                <a:latin typeface="Google Sans"/>
              </a:rPr>
              <a:t>tx</a:t>
            </a:r>
            <a:r>
              <a:rPr lang="en-US" sz="800" b="0" i="0" dirty="0">
                <a:solidFill>
                  <a:srgbClr val="202124"/>
                </a:solidFill>
                <a:effectLst/>
                <a:latin typeface="Google Sans"/>
              </a:rPr>
              <a:t> treatment,</a:t>
            </a:r>
            <a:r>
              <a:rPr lang="en-US" sz="800" dirty="0"/>
              <a:t> </a:t>
            </a:r>
            <a:r>
              <a:rPr lang="en-US" sz="800" i="1" dirty="0">
                <a:effectLst/>
                <a:ea typeface="Calibri" panose="020F0502020204030204" pitchFamily="34" charset="0"/>
              </a:rPr>
              <a:t>ns</a:t>
            </a:r>
            <a:r>
              <a:rPr lang="en-US" sz="800" dirty="0">
                <a:effectLst/>
                <a:ea typeface="Calibri" panose="020F0502020204030204" pitchFamily="34" charset="0"/>
              </a:rPr>
              <a:t> not significant, </a:t>
            </a:r>
            <a:r>
              <a:rPr lang="en-US" sz="800" i="1" dirty="0">
                <a:effectLst/>
                <a:ea typeface="Calibri" panose="020F0502020204030204" pitchFamily="34" charset="0"/>
              </a:rPr>
              <a:t>sTIM3</a:t>
            </a:r>
            <a:r>
              <a:rPr lang="en-US" sz="800" dirty="0">
                <a:effectLst/>
                <a:ea typeface="Calibri" panose="020F0502020204030204" pitchFamily="34" charset="0"/>
              </a:rPr>
              <a:t> soluble T cell immunoglobulin and mucin domain-containing protein 3, </a:t>
            </a:r>
            <a:r>
              <a:rPr lang="en-US" sz="800" i="1" dirty="0">
                <a:effectLst/>
                <a:ea typeface="Calibri" panose="020F0502020204030204" pitchFamily="34" charset="0"/>
              </a:rPr>
              <a:t>sLAG3 </a:t>
            </a:r>
            <a:r>
              <a:rPr lang="en-US" sz="800" dirty="0">
                <a:effectLst/>
                <a:ea typeface="Calibri" panose="020F0502020204030204" pitchFamily="34" charset="0"/>
              </a:rPr>
              <a:t>soluble lymphocyte activation gene 3, </a:t>
            </a:r>
            <a:r>
              <a:rPr lang="en-US" sz="800" i="1" dirty="0" err="1">
                <a:effectLst/>
                <a:ea typeface="Calibri" panose="020F0502020204030204" pitchFamily="34" charset="0"/>
              </a:rPr>
              <a:t>hIO</a:t>
            </a:r>
            <a:r>
              <a:rPr lang="en-US" sz="800" i="1" dirty="0">
                <a:effectLst/>
                <a:ea typeface="Calibri" panose="020F0502020204030204" pitchFamily="34" charset="0"/>
              </a:rPr>
              <a:t> </a:t>
            </a:r>
            <a:r>
              <a:rPr lang="en-US" sz="800" dirty="0">
                <a:effectLst/>
                <a:ea typeface="Calibri" panose="020F0502020204030204" pitchFamily="34" charset="0"/>
              </a:rPr>
              <a:t>human Immuno-Oncology.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8384127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E3CF876-6408-7F43-FC71-B23A82AD36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8494465"/>
              </p:ext>
            </p:extLst>
          </p:nvPr>
        </p:nvGraphicFramePr>
        <p:xfrm>
          <a:off x="77553" y="212820"/>
          <a:ext cx="6684264" cy="5302996"/>
        </p:xfrm>
        <a:graphic>
          <a:graphicData uri="http://schemas.openxmlformats.org/drawingml/2006/table">
            <a:tbl>
              <a:tblPr/>
              <a:tblGrid>
                <a:gridCol w="448056">
                  <a:extLst>
                    <a:ext uri="{9D8B030D-6E8A-4147-A177-3AD203B41FA5}">
                      <a16:colId xmlns:a16="http://schemas.microsoft.com/office/drawing/2014/main" val="2313936930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1294153392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58142169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212820761"/>
                    </a:ext>
                  </a:extLst>
                </a:gridCol>
                <a:gridCol w="1280160">
                  <a:extLst>
                    <a:ext uri="{9D8B030D-6E8A-4147-A177-3AD203B41FA5}">
                      <a16:colId xmlns:a16="http://schemas.microsoft.com/office/drawing/2014/main" val="1098854793"/>
                    </a:ext>
                  </a:extLst>
                </a:gridCol>
                <a:gridCol w="612648">
                  <a:extLst>
                    <a:ext uri="{9D8B030D-6E8A-4147-A177-3AD203B41FA5}">
                      <a16:colId xmlns:a16="http://schemas.microsoft.com/office/drawing/2014/main" val="1685093643"/>
                    </a:ext>
                  </a:extLst>
                </a:gridCol>
                <a:gridCol w="649224">
                  <a:extLst>
                    <a:ext uri="{9D8B030D-6E8A-4147-A177-3AD203B41FA5}">
                      <a16:colId xmlns:a16="http://schemas.microsoft.com/office/drawing/2014/main" val="228343696"/>
                    </a:ext>
                  </a:extLst>
                </a:gridCol>
                <a:gridCol w="649224">
                  <a:extLst>
                    <a:ext uri="{9D8B030D-6E8A-4147-A177-3AD203B41FA5}">
                      <a16:colId xmlns:a16="http://schemas.microsoft.com/office/drawing/2014/main" val="1650835844"/>
                    </a:ext>
                  </a:extLst>
                </a:gridCol>
                <a:gridCol w="576072">
                  <a:extLst>
                    <a:ext uri="{9D8B030D-6E8A-4147-A177-3AD203B41FA5}">
                      <a16:colId xmlns:a16="http://schemas.microsoft.com/office/drawing/2014/main" val="2373448078"/>
                    </a:ext>
                  </a:extLst>
                </a:gridCol>
              </a:tblGrid>
              <a:tr h="40482"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8.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anges in </a:t>
                      </a:r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BTLA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nd </a:t>
                      </a:r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VEM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upon treatment with conventional therapies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6373067"/>
                  </a:ext>
                </a:extLst>
              </a:tr>
              <a:tr h="418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2075114"/>
                  </a:ext>
                </a:extLst>
              </a:tr>
              <a:tr h="1190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alyt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cer Type (n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terial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od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</a:t>
                      </a:r>
                    </a:p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 Chang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epoint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1191184"/>
                  </a:ext>
                </a:extLst>
              </a:tr>
              <a:tr h="404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BTL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53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orafeni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5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2355497"/>
                  </a:ext>
                </a:extLst>
              </a:tr>
              <a:tr h="80964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cervical (n=5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urrent chemoradiotherapy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®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 after end of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4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0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2726122"/>
                  </a:ext>
                </a:extLst>
              </a:tr>
              <a:tr h="40482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4190736"/>
                  </a:ext>
                </a:extLst>
              </a:tr>
              <a:tr h="418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4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nvatini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9691359"/>
                  </a:ext>
                </a:extLst>
              </a:tr>
              <a:tr h="41878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sopharyngeal (n=3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initive intensity-modulated 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1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Bioscienc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5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0592628"/>
                  </a:ext>
                </a:extLst>
              </a:tr>
              <a:tr h="41878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rly breast (n=7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therapy and 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® MAP Kit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1-11K-PX17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erck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367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2138990"/>
                  </a:ext>
                </a:extLst>
              </a:tr>
              <a:tr h="404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VE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CE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03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0100812"/>
                  </a:ext>
                </a:extLst>
              </a:tr>
              <a:tr h="80964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arly breast (n=72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therapy and surger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® MAP Kit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1-11K-PX17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erck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=0.00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7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031684"/>
                  </a:ext>
                </a:extLst>
              </a:tr>
              <a:tr h="80964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24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nvatinib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week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3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9299543"/>
                  </a:ext>
                </a:extLst>
              </a:tr>
              <a:tr h="80964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cally advanced cervical (n=51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urrent chemo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®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Protein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KPMAG-11K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0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136053"/>
                  </a:ext>
                </a:extLst>
              </a:tr>
              <a:tr h="80964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sopharyngeal (n=37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finitive intensity-modulated radiotherapy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anel 1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Bioscienc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=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65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9610545"/>
                  </a:ext>
                </a:extLst>
              </a:tr>
              <a:tr h="80964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atocellular (n=53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orafenib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sma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plexed immunoassays with the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lli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ap Kit (EMD Millipore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week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34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37]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2960892"/>
                  </a:ext>
                </a:extLst>
              </a:tr>
              <a:tr h="40482"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astatic renal cell (n=20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ed therapy (sunitinib or pazopanib) first-line 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IO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heckpoint 14-Plex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ocartaPlex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Panel 1,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PX14A-15803-901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Bioscienc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-4 months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=0.01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245]</a:t>
                      </a:r>
                    </a:p>
                  </a:txBody>
                  <a:tcPr marL="1396" marR="1396" marT="1396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8056446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40E4C1F-FB38-674D-E371-1C354AFA3A0E}"/>
              </a:ext>
            </a:extLst>
          </p:cNvPr>
          <p:cNvSpPr txBox="1"/>
          <p:nvPr/>
        </p:nvSpPr>
        <p:spPr>
          <a:xfrm>
            <a:off x="96183" y="5522166"/>
            <a:ext cx="650272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i="1" dirty="0"/>
              <a:t>Abbreviations: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sBTLA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B and T lymphocyte attenuator,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tx</a:t>
            </a:r>
            <a:r>
              <a:rPr lang="en-US" sz="1000" dirty="0">
                <a:effectLst/>
                <a:ea typeface="Calibri" panose="020F0502020204030204" pitchFamily="34" charset="0"/>
              </a:rPr>
              <a:t> treatment,</a:t>
            </a:r>
            <a:r>
              <a:rPr lang="en-US" sz="1000" i="1" dirty="0"/>
              <a:t> </a:t>
            </a:r>
            <a:r>
              <a:rPr lang="en-US" sz="1000" i="1" dirty="0" err="1"/>
              <a:t>hIO</a:t>
            </a:r>
            <a:r>
              <a:rPr lang="en-US" sz="1000" i="1" dirty="0"/>
              <a:t> </a:t>
            </a:r>
            <a:r>
              <a:rPr lang="en-US" sz="1000" dirty="0"/>
              <a:t>human Immuno-Oncology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TACE</a:t>
            </a:r>
            <a:r>
              <a:rPr lang="en-US" sz="10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b="0" i="0" dirty="0" err="1">
                <a:solidFill>
                  <a:srgbClr val="202124"/>
                </a:solidFill>
                <a:effectLst/>
                <a:latin typeface="Google Sans"/>
              </a:rPr>
              <a:t>transarterial</a:t>
            </a:r>
            <a:r>
              <a:rPr lang="en-US" sz="1000" b="0" i="0" dirty="0">
                <a:solidFill>
                  <a:srgbClr val="202124"/>
                </a:solidFill>
                <a:effectLst/>
                <a:latin typeface="Google Sans"/>
              </a:rPr>
              <a:t> chemoembolization, </a:t>
            </a:r>
            <a:r>
              <a:rPr lang="en-US" sz="1000" i="1" dirty="0">
                <a:effectLst/>
                <a:ea typeface="Calibri" panose="020F0502020204030204" pitchFamily="34" charset="0"/>
              </a:rPr>
              <a:t>ns</a:t>
            </a:r>
            <a:r>
              <a:rPr lang="en-US" sz="1000" dirty="0">
                <a:effectLst/>
                <a:ea typeface="Calibri" panose="020F0502020204030204" pitchFamily="34" charset="0"/>
              </a:rPr>
              <a:t> not significant, </a:t>
            </a:r>
            <a:r>
              <a:rPr lang="en-US" sz="1000" i="1" dirty="0" err="1">
                <a:effectLst/>
                <a:ea typeface="Calibri" panose="020F0502020204030204" pitchFamily="34" charset="0"/>
              </a:rPr>
              <a:t>sHVEM</a:t>
            </a:r>
            <a:r>
              <a:rPr lang="en-US" sz="1000" dirty="0">
                <a:effectLst/>
                <a:ea typeface="Calibri" panose="020F0502020204030204" pitchFamily="34" charset="0"/>
              </a:rPr>
              <a:t> soluble herpesvirus entry mediator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609320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030</TotalTime>
  <Words>5050</Words>
  <Application>Microsoft Office PowerPoint</Application>
  <PresentationFormat>A4 Paper (210x297 mm)</PresentationFormat>
  <Paragraphs>1342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Google San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nahue, Renee (NIH/NCI) [E]</dc:creator>
  <cp:lastModifiedBy>Pitts, Steffie (NIH/NCI) [F]</cp:lastModifiedBy>
  <cp:revision>132</cp:revision>
  <cp:lastPrinted>2024-02-09T22:39:21Z</cp:lastPrinted>
  <dcterms:created xsi:type="dcterms:W3CDTF">2023-12-15T13:15:32Z</dcterms:created>
  <dcterms:modified xsi:type="dcterms:W3CDTF">2024-05-22T21:06:47Z</dcterms:modified>
</cp:coreProperties>
</file>